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280" y="-10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FN_manip%202012_tous\Compil%20IFN_v9.0_Tstr_cin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FN_manip%202012_tous\Compil%20IFN_v9.0_Tstr_cin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FN_manip%202012_tous\Compil%20IFN_v9.0_Tstr_cin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L10_manip%202012_tous\Compil%20IL10_v%209.0_Tstrepto_cin&#233;tique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L10_manip%202012_tous\Compil%20IL10_v%209.0_Tstrepto_cin&#233;tique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L10_manip%202012_tous\Compil%20IL10_v%209.0_Tstrepto_cin&#233;tique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FN_manip%202012_tous\Compil%20IFN_v9.0_Tstr_cin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IL10_manip%202012_tous\Compil%20IL10_v%209.0_Tstrepto_cin&#233;tique.xlsx" TargetMode="External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6571302235289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FN 15min str'!$AS$1:$AT$1</c:f>
              <c:strCache>
                <c:ptCount val="1"/>
                <c:pt idx="0">
                  <c:v>IFN_I CEC Col_15 min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3"/>
            <c:invertIfNegative val="0"/>
            <c:bubble3D val="0"/>
          </c:dPt>
          <c:cat>
            <c:strRef>
              <c:f>'IFN 15min str'!$AM$2:$AM$15</c:f>
              <c:strCache>
                <c:ptCount val="14"/>
                <c:pt idx="0">
                  <c:v>T Strepto_I_-_T2</c:v>
                </c:pt>
                <c:pt idx="1">
                  <c:v>WT_ I_O_1_15 min</c:v>
                </c:pt>
                <c:pt idx="2">
                  <c:v>WT_ I_-_1_15 min</c:v>
                </c:pt>
                <c:pt idx="3">
                  <c:v>T Sb Strepto_I_-_T3</c:v>
                </c:pt>
                <c:pt idx="4">
                  <c:v>WT+Sb_I_O_2_15 min</c:v>
                </c:pt>
                <c:pt idx="5">
                  <c:v>WT+Sb_ I_-_2_15 min</c:v>
                </c:pt>
                <c:pt idx="6">
                  <c:v>T Strepto_CEC_-_T2</c:v>
                </c:pt>
                <c:pt idx="7">
                  <c:v>WT_C_CEC_-_1_15 min</c:v>
                </c:pt>
                <c:pt idx="8">
                  <c:v>T Sb Strepto_CEC_-_T3</c:v>
                </c:pt>
                <c:pt idx="9">
                  <c:v>WT+Sb_CEC_-_2_15 min</c:v>
                </c:pt>
                <c:pt idx="10">
                  <c:v>T Strepto_Col._-_T2</c:v>
                </c:pt>
                <c:pt idx="11">
                  <c:v>WT_J_Col._-_1_15 min</c:v>
                </c:pt>
                <c:pt idx="12">
                  <c:v>T Sb Strepto_Col._-_T3</c:v>
                </c:pt>
                <c:pt idx="13">
                  <c:v>WT+Sb_Col._-_2_15 min</c:v>
                </c:pt>
              </c:strCache>
            </c:strRef>
          </c:cat>
          <c:val>
            <c:numRef>
              <c:f>'IFN 15min str'!$AQ$2:$AQ$15</c:f>
              <c:numCache>
                <c:formatCode>General</c:formatCode>
                <c:ptCount val="14"/>
                <c:pt idx="0">
                  <c:v>1.0</c:v>
                </c:pt>
                <c:pt idx="1">
                  <c:v>0.213188100993085</c:v>
                </c:pt>
                <c:pt idx="2">
                  <c:v>1.701932437909392</c:v>
                </c:pt>
                <c:pt idx="3">
                  <c:v>1.0</c:v>
                </c:pt>
                <c:pt idx="4">
                  <c:v>7.50907964175411</c:v>
                </c:pt>
                <c:pt idx="5">
                  <c:v>0.435063618270073</c:v>
                </c:pt>
                <c:pt idx="6">
                  <c:v>1.0</c:v>
                </c:pt>
                <c:pt idx="7">
                  <c:v>0.431386266936483</c:v>
                </c:pt>
                <c:pt idx="8">
                  <c:v>1.0</c:v>
                </c:pt>
                <c:pt idx="9">
                  <c:v>5.090771029552652</c:v>
                </c:pt>
                <c:pt idx="10">
                  <c:v>1.0</c:v>
                </c:pt>
                <c:pt idx="11">
                  <c:v>1.064088897116447</c:v>
                </c:pt>
                <c:pt idx="12">
                  <c:v>1.0</c:v>
                </c:pt>
                <c:pt idx="13">
                  <c:v>0.7506628303587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517416"/>
        <c:axId val="507256856"/>
      </c:barChart>
      <c:catAx>
        <c:axId val="145174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507256856"/>
        <c:crossesAt val="0.1"/>
        <c:auto val="1"/>
        <c:lblAlgn val="ctr"/>
        <c:lblOffset val="100"/>
        <c:noMultiLvlLbl val="0"/>
      </c:catAx>
      <c:valAx>
        <c:axId val="507256856"/>
        <c:scaling>
          <c:logBase val="10.0"/>
          <c:orientation val="minMax"/>
          <c:max val="1000.0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14517416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5556461595289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FN 45min Str'!$AS$1:$AT$1</c:f>
              <c:strCache>
                <c:ptCount val="1"/>
                <c:pt idx="0">
                  <c:v>IFN_I CEC Col_45 min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4"/>
            <c:invertIfNegative val="0"/>
            <c:bubble3D val="0"/>
          </c:dPt>
          <c:cat>
            <c:strRef>
              <c:f>'IFN 45min Str'!$AM$2:$AM$16</c:f>
              <c:strCache>
                <c:ptCount val="15"/>
                <c:pt idx="0">
                  <c:v>T Strepto_I_-_T2</c:v>
                </c:pt>
                <c:pt idx="1">
                  <c:v>WT_ I_+_3_45 min</c:v>
                </c:pt>
                <c:pt idx="2">
                  <c:v>WT_ I_O_3_45 min</c:v>
                </c:pt>
                <c:pt idx="3">
                  <c:v>WT_I_-_3_45 min</c:v>
                </c:pt>
                <c:pt idx="4">
                  <c:v>T Sb Strepto_I_-_T3</c:v>
                </c:pt>
                <c:pt idx="5">
                  <c:v>WT+Sb_I_+_4bis_45 min</c:v>
                </c:pt>
                <c:pt idx="6">
                  <c:v>WT+Sb_I_O_4bis_45 min</c:v>
                </c:pt>
                <c:pt idx="7">
                  <c:v>T Strepto_CEC_-_T2</c:v>
                </c:pt>
                <c:pt idx="8">
                  <c:v>WT_ CEC_-_3_45 min</c:v>
                </c:pt>
                <c:pt idx="9">
                  <c:v>T Sb Strepto_CEC_-_T3</c:v>
                </c:pt>
                <c:pt idx="10">
                  <c:v>WT+Sb_CEC_O_4bis_45 min</c:v>
                </c:pt>
                <c:pt idx="11">
                  <c:v>T Strepto_Col._-_T2</c:v>
                </c:pt>
                <c:pt idx="12">
                  <c:v>WT_moy Col._-_3_45 min</c:v>
                </c:pt>
                <c:pt idx="13">
                  <c:v>T Sb Strepto_Col._-_T3</c:v>
                </c:pt>
                <c:pt idx="14">
                  <c:v>WT+Sb_Col._-_4bis_45 min</c:v>
                </c:pt>
              </c:strCache>
            </c:strRef>
          </c:cat>
          <c:val>
            <c:numRef>
              <c:f>'IFN 45min Str'!$AQ$2:$AQ$16</c:f>
              <c:numCache>
                <c:formatCode>General</c:formatCode>
                <c:ptCount val="15"/>
                <c:pt idx="0">
                  <c:v>1.0</c:v>
                </c:pt>
                <c:pt idx="1">
                  <c:v>1.242102468406321</c:v>
                </c:pt>
                <c:pt idx="2">
                  <c:v>0.512295289353457</c:v>
                </c:pt>
                <c:pt idx="3">
                  <c:v>2.322824883060766</c:v>
                </c:pt>
                <c:pt idx="4">
                  <c:v>1.0</c:v>
                </c:pt>
                <c:pt idx="5">
                  <c:v>4.29054809669634</c:v>
                </c:pt>
                <c:pt idx="6">
                  <c:v>6.994759305264285</c:v>
                </c:pt>
                <c:pt idx="7">
                  <c:v>1.0</c:v>
                </c:pt>
                <c:pt idx="8">
                  <c:v>9.001717864516681</c:v>
                </c:pt>
                <c:pt idx="9">
                  <c:v>1.0</c:v>
                </c:pt>
                <c:pt idx="10">
                  <c:v>0.318854948294443</c:v>
                </c:pt>
                <c:pt idx="11">
                  <c:v>1.0</c:v>
                </c:pt>
                <c:pt idx="12">
                  <c:v>7.96677936084877</c:v>
                </c:pt>
                <c:pt idx="13">
                  <c:v>1.0</c:v>
                </c:pt>
                <c:pt idx="14">
                  <c:v>1.074584429609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5492840"/>
        <c:axId val="506565576"/>
      </c:barChart>
      <c:catAx>
        <c:axId val="5254928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506565576"/>
        <c:crossesAt val="0.1"/>
        <c:auto val="1"/>
        <c:lblAlgn val="ctr"/>
        <c:lblOffset val="100"/>
        <c:noMultiLvlLbl val="0"/>
      </c:catAx>
      <c:valAx>
        <c:axId val="506565576"/>
        <c:scaling>
          <c:logBase val="10.0"/>
          <c:orientation val="minMax"/>
          <c:max val="1000.0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525492840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4843825965623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FN 90min str'!$AS$1:$AT$1</c:f>
              <c:strCache>
                <c:ptCount val="1"/>
                <c:pt idx="0">
                  <c:v>IFN_I CEC Col_90 min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cat>
            <c:strRef>
              <c:f>'IFN 90min str'!$AM$2:$AM$14</c:f>
              <c:strCache>
                <c:ptCount val="13"/>
                <c:pt idx="0">
                  <c:v>T Strepto_I_-_T2</c:v>
                </c:pt>
                <c:pt idx="1">
                  <c:v>WT_ I_+_5_90 min</c:v>
                </c:pt>
                <c:pt idx="2">
                  <c:v>WT_I_O_5_90 min</c:v>
                </c:pt>
                <c:pt idx="3">
                  <c:v>T Sb Strepto_I_-_T3</c:v>
                </c:pt>
                <c:pt idx="4">
                  <c:v>WT+Sb_I_+_6_90 min</c:v>
                </c:pt>
                <c:pt idx="5">
                  <c:v>T Strepto_CEC_-_T2</c:v>
                </c:pt>
                <c:pt idx="6">
                  <c:v>WT_ CEC_O_5_90 min</c:v>
                </c:pt>
                <c:pt idx="7">
                  <c:v>T Sb Strepto_CEC_-_T3</c:v>
                </c:pt>
                <c:pt idx="8">
                  <c:v>WT+Sb_CEC_O_6_90 min</c:v>
                </c:pt>
                <c:pt idx="9">
                  <c:v>T Strepto_Col._-_T2</c:v>
                </c:pt>
                <c:pt idx="10">
                  <c:v>WT_Col._-_5_90 min</c:v>
                </c:pt>
                <c:pt idx="11">
                  <c:v>T Sb Strepto_Col._-_T3</c:v>
                </c:pt>
                <c:pt idx="12">
                  <c:v>WT+Sb_Col._O_6_90 min</c:v>
                </c:pt>
              </c:strCache>
            </c:strRef>
          </c:cat>
          <c:val>
            <c:numRef>
              <c:f>'IFN 90min str'!$AQ$2:$AQ$14</c:f>
              <c:numCache>
                <c:formatCode>General</c:formatCode>
                <c:ptCount val="13"/>
                <c:pt idx="0">
                  <c:v>1.0</c:v>
                </c:pt>
                <c:pt idx="1">
                  <c:v>0.982286966011141</c:v>
                </c:pt>
                <c:pt idx="2">
                  <c:v>3.133418573490228</c:v>
                </c:pt>
                <c:pt idx="3">
                  <c:v>1.0</c:v>
                </c:pt>
                <c:pt idx="4">
                  <c:v>1.152431816656662</c:v>
                </c:pt>
                <c:pt idx="5">
                  <c:v>1.0</c:v>
                </c:pt>
                <c:pt idx="6">
                  <c:v>0.395451179519219</c:v>
                </c:pt>
                <c:pt idx="7">
                  <c:v>1.0</c:v>
                </c:pt>
                <c:pt idx="8">
                  <c:v>0.701755965713592</c:v>
                </c:pt>
                <c:pt idx="9">
                  <c:v>1.0</c:v>
                </c:pt>
                <c:pt idx="10">
                  <c:v>0.991822223999552</c:v>
                </c:pt>
                <c:pt idx="11">
                  <c:v>1.0</c:v>
                </c:pt>
                <c:pt idx="12">
                  <c:v>0.2022802666152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28439192"/>
        <c:axId val="627066920"/>
      </c:barChart>
      <c:catAx>
        <c:axId val="6284391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627066920"/>
        <c:crossesAt val="0.001"/>
        <c:auto val="1"/>
        <c:lblAlgn val="ctr"/>
        <c:lblOffset val="100"/>
        <c:noMultiLvlLbl val="0"/>
      </c:catAx>
      <c:valAx>
        <c:axId val="627066920"/>
        <c:scaling>
          <c:logBase val="10.0"/>
          <c:orientation val="minMax"/>
          <c:max val="1000.0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628439192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537315987488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10 15min Str'!$AS$1:$AT$1</c:f>
              <c:strCache>
                <c:ptCount val="1"/>
                <c:pt idx="0">
                  <c:v>IL10_I CEC Col_15 min / T.STREPTO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2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cat>
            <c:strRef>
              <c:f>'IL10 15min Str'!$AM$2:$AM$15</c:f>
              <c:strCache>
                <c:ptCount val="14"/>
                <c:pt idx="0">
                  <c:v>T Strepto_I_-_T2</c:v>
                </c:pt>
                <c:pt idx="1">
                  <c:v>WT_ I_O_1_15 min</c:v>
                </c:pt>
                <c:pt idx="2">
                  <c:v>WT_ I_-_1_15 min</c:v>
                </c:pt>
                <c:pt idx="3">
                  <c:v>T Sb Strepto_I_-_T3</c:v>
                </c:pt>
                <c:pt idx="4">
                  <c:v>WT+Sb_I_O_2_15 min</c:v>
                </c:pt>
                <c:pt idx="5">
                  <c:v>WT+Sb_ I_-_2_15 min</c:v>
                </c:pt>
                <c:pt idx="6">
                  <c:v>T Strepto_CEC_-_T2</c:v>
                </c:pt>
                <c:pt idx="7">
                  <c:v>WT_C_CEC_-_1_15 min</c:v>
                </c:pt>
                <c:pt idx="8">
                  <c:v>T Sb Strepto_CEC_-_T3</c:v>
                </c:pt>
                <c:pt idx="9">
                  <c:v>WT+Sb_CEC_-_2_15 min</c:v>
                </c:pt>
                <c:pt idx="10">
                  <c:v>T Strepto_Col._-_T2</c:v>
                </c:pt>
                <c:pt idx="11">
                  <c:v>WT_J_Col._-_1_15 min</c:v>
                </c:pt>
                <c:pt idx="12">
                  <c:v>T Sb Strepto_Col._-_T3</c:v>
                </c:pt>
                <c:pt idx="13">
                  <c:v>WT+Sb_Col._-_2_15 min</c:v>
                </c:pt>
              </c:strCache>
            </c:strRef>
          </c:cat>
          <c:val>
            <c:numRef>
              <c:f>'IL10 15min Str'!$AQ$2:$AQ$15</c:f>
              <c:numCache>
                <c:formatCode>General</c:formatCode>
                <c:ptCount val="14"/>
                <c:pt idx="0">
                  <c:v>1.0</c:v>
                </c:pt>
                <c:pt idx="1">
                  <c:v>0.856886425896964</c:v>
                </c:pt>
                <c:pt idx="2">
                  <c:v>31.24169224394298</c:v>
                </c:pt>
                <c:pt idx="3">
                  <c:v>1.0</c:v>
                </c:pt>
                <c:pt idx="4">
                  <c:v>0.651645924871031</c:v>
                </c:pt>
                <c:pt idx="5">
                  <c:v>0.252903143706286</c:v>
                </c:pt>
                <c:pt idx="6">
                  <c:v>1.0</c:v>
                </c:pt>
                <c:pt idx="7">
                  <c:v>0.378480136069454</c:v>
                </c:pt>
                <c:pt idx="8">
                  <c:v>1.0</c:v>
                </c:pt>
                <c:pt idx="9">
                  <c:v>2.056306436480002</c:v>
                </c:pt>
                <c:pt idx="10">
                  <c:v>1.0</c:v>
                </c:pt>
                <c:pt idx="11">
                  <c:v>0.490779994067431</c:v>
                </c:pt>
                <c:pt idx="12">
                  <c:v>1.0</c:v>
                </c:pt>
                <c:pt idx="13">
                  <c:v>1.326781107315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23293512"/>
        <c:axId val="627724504"/>
      </c:barChart>
      <c:catAx>
        <c:axId val="4232935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627724504"/>
        <c:crossesAt val="0.1"/>
        <c:auto val="1"/>
        <c:lblAlgn val="ctr"/>
        <c:lblOffset val="100"/>
        <c:noMultiLvlLbl val="0"/>
      </c:catAx>
      <c:valAx>
        <c:axId val="627724504"/>
        <c:scaling>
          <c:logBase val="10.0"/>
          <c:orientation val="minMax"/>
          <c:max val="1000.0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423293512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7107200730343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10 45min Str'!$AS$1:$AT$1</c:f>
              <c:strCache>
                <c:ptCount val="1"/>
                <c:pt idx="0">
                  <c:v>IL10_I CEC Col_45 min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4"/>
            <c:invertIfNegative val="0"/>
            <c:bubble3D val="0"/>
          </c:dPt>
          <c:cat>
            <c:strRef>
              <c:f>'IL10 45min Str'!$AM$2:$AM$16</c:f>
              <c:strCache>
                <c:ptCount val="15"/>
                <c:pt idx="0">
                  <c:v>T Strepto_I_-_T2</c:v>
                </c:pt>
                <c:pt idx="1">
                  <c:v>WT_ I_+_3_45 min</c:v>
                </c:pt>
                <c:pt idx="2">
                  <c:v>WT_ I_O_3_45 min</c:v>
                </c:pt>
                <c:pt idx="3">
                  <c:v>WT_I_-_3_45 min</c:v>
                </c:pt>
                <c:pt idx="4">
                  <c:v>T Sb Strepto_I_-_T3</c:v>
                </c:pt>
                <c:pt idx="5">
                  <c:v>WT+Sb_I_+_4bis_45 min</c:v>
                </c:pt>
                <c:pt idx="6">
                  <c:v>WT+Sb_I_O_4bis_45 min</c:v>
                </c:pt>
                <c:pt idx="7">
                  <c:v>T Strepto_CEC_-_T2</c:v>
                </c:pt>
                <c:pt idx="8">
                  <c:v>WT_ CEC_-_3_45 min</c:v>
                </c:pt>
                <c:pt idx="9">
                  <c:v>T Sb Strepto_CEC_-_T3</c:v>
                </c:pt>
                <c:pt idx="10">
                  <c:v>WT+Sb_CEC_O_4bis_45 min</c:v>
                </c:pt>
                <c:pt idx="11">
                  <c:v>T Strepto_Col._-_T2</c:v>
                </c:pt>
                <c:pt idx="12">
                  <c:v>WT_moy Col._-_3_45 min</c:v>
                </c:pt>
                <c:pt idx="13">
                  <c:v>T Sb Strepto_Col._-_T3</c:v>
                </c:pt>
                <c:pt idx="14">
                  <c:v>WT+Sb_Col._-_4bis_45 min</c:v>
                </c:pt>
              </c:strCache>
            </c:strRef>
          </c:cat>
          <c:val>
            <c:numRef>
              <c:f>'IL10 45min Str'!$AQ$2:$AQ$16</c:f>
              <c:numCache>
                <c:formatCode>General</c:formatCode>
                <c:ptCount val="15"/>
                <c:pt idx="0">
                  <c:v>1.0</c:v>
                </c:pt>
                <c:pt idx="1">
                  <c:v>0.81932255330881</c:v>
                </c:pt>
                <c:pt idx="2">
                  <c:v>68.66184004510451</c:v>
                </c:pt>
                <c:pt idx="3">
                  <c:v>115.7752167441341</c:v>
                </c:pt>
                <c:pt idx="4">
                  <c:v>1.0</c:v>
                </c:pt>
                <c:pt idx="5">
                  <c:v>2.683411765421788</c:v>
                </c:pt>
                <c:pt idx="6">
                  <c:v>3.0474148435548</c:v>
                </c:pt>
                <c:pt idx="7">
                  <c:v>1.0</c:v>
                </c:pt>
                <c:pt idx="8">
                  <c:v>0.948509852708574</c:v>
                </c:pt>
                <c:pt idx="9">
                  <c:v>1.0</c:v>
                </c:pt>
                <c:pt idx="10">
                  <c:v>1.27641841342635</c:v>
                </c:pt>
                <c:pt idx="11">
                  <c:v>1.0</c:v>
                </c:pt>
                <c:pt idx="12">
                  <c:v>0.162283137650668</c:v>
                </c:pt>
                <c:pt idx="13">
                  <c:v>1.0</c:v>
                </c:pt>
                <c:pt idx="14">
                  <c:v>0.3076311481281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5956120"/>
        <c:axId val="14020552"/>
      </c:barChart>
      <c:catAx>
        <c:axId val="5259561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14020552"/>
        <c:crossesAt val="0.1"/>
        <c:auto val="1"/>
        <c:lblAlgn val="ctr"/>
        <c:lblOffset val="100"/>
        <c:noMultiLvlLbl val="0"/>
      </c:catAx>
      <c:valAx>
        <c:axId val="14020552"/>
        <c:scaling>
          <c:logBase val="10.0"/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525956120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5784725283696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10 90min Str'!$AS$1:$AT$1</c:f>
              <c:strCache>
                <c:ptCount val="1"/>
                <c:pt idx="0">
                  <c:v>IL10_I CEC Col_90 min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cat>
            <c:strRef>
              <c:f>'IL10 90min Str'!$AM$2:$AM$14</c:f>
              <c:strCache>
                <c:ptCount val="13"/>
                <c:pt idx="0">
                  <c:v>T Strepto_I_-_T2</c:v>
                </c:pt>
                <c:pt idx="1">
                  <c:v>WT_ I_+_5_90 min</c:v>
                </c:pt>
                <c:pt idx="2">
                  <c:v>WT_I_O_5_90 min</c:v>
                </c:pt>
                <c:pt idx="3">
                  <c:v>T Sb Strepto_I_-_T3</c:v>
                </c:pt>
                <c:pt idx="4">
                  <c:v>WT+Sb_I_+_6_90 min</c:v>
                </c:pt>
                <c:pt idx="5">
                  <c:v>T Strepto_CEC_-_T2</c:v>
                </c:pt>
                <c:pt idx="6">
                  <c:v>WT_ CEC_O_5_90 min</c:v>
                </c:pt>
                <c:pt idx="7">
                  <c:v>T Sb Strepto_CEC_-_T3</c:v>
                </c:pt>
                <c:pt idx="8">
                  <c:v>WT+Sb_CEC_O_6_90 min</c:v>
                </c:pt>
                <c:pt idx="9">
                  <c:v>T Strepto_Col._-_T2</c:v>
                </c:pt>
                <c:pt idx="10">
                  <c:v>WT_Col._-_5_90 min</c:v>
                </c:pt>
                <c:pt idx="11">
                  <c:v>T Sb Strepto_Col._-_T3</c:v>
                </c:pt>
                <c:pt idx="12">
                  <c:v>WT+Sb_Col._O_6_90 min</c:v>
                </c:pt>
              </c:strCache>
            </c:strRef>
          </c:cat>
          <c:val>
            <c:numRef>
              <c:f>'IL10 90min Str'!$AQ$2:$AQ$14</c:f>
              <c:numCache>
                <c:formatCode>General</c:formatCode>
                <c:ptCount val="13"/>
                <c:pt idx="0">
                  <c:v>1.0</c:v>
                </c:pt>
                <c:pt idx="1">
                  <c:v>34.99525579228064</c:v>
                </c:pt>
                <c:pt idx="2">
                  <c:v>50.85506987375089</c:v>
                </c:pt>
                <c:pt idx="3">
                  <c:v>1.0</c:v>
                </c:pt>
                <c:pt idx="4">
                  <c:v>0.803682796279063</c:v>
                </c:pt>
                <c:pt idx="5">
                  <c:v>1.0</c:v>
                </c:pt>
                <c:pt idx="6">
                  <c:v>1.023012350669598</c:v>
                </c:pt>
                <c:pt idx="7">
                  <c:v>1.0</c:v>
                </c:pt>
                <c:pt idx="8">
                  <c:v>0.357846590563899</c:v>
                </c:pt>
                <c:pt idx="9">
                  <c:v>1.0</c:v>
                </c:pt>
                <c:pt idx="10">
                  <c:v>0.337726110808512</c:v>
                </c:pt>
                <c:pt idx="11">
                  <c:v>1.0</c:v>
                </c:pt>
                <c:pt idx="12">
                  <c:v>1.656620187110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02986632"/>
        <c:axId val="627970152"/>
      </c:barChart>
      <c:catAx>
        <c:axId val="5029866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627970152"/>
        <c:crossesAt val="0.001"/>
        <c:auto val="1"/>
        <c:lblAlgn val="ctr"/>
        <c:lblOffset val="100"/>
        <c:noMultiLvlLbl val="0"/>
      </c:catAx>
      <c:valAx>
        <c:axId val="627970152"/>
        <c:scaling>
          <c:logBase val="10.0"/>
          <c:orientation val="minMax"/>
          <c:max val="1000.0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502986632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5044106309153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FN 6h str'!$AS$1:$AT$1</c:f>
              <c:strCache>
                <c:ptCount val="1"/>
                <c:pt idx="0">
                  <c:v>IFN_I CEC Col_6h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cat>
            <c:strRef>
              <c:f>'IFN 6h str'!$AM$2:$AM$13</c:f>
              <c:strCache>
                <c:ptCount val="12"/>
                <c:pt idx="0">
                  <c:v>T Strepto_I_-_T2</c:v>
                </c:pt>
                <c:pt idx="1">
                  <c:v>WT_I_+_7_6h</c:v>
                </c:pt>
                <c:pt idx="2">
                  <c:v>T Sb Strepto_I_-_T3</c:v>
                </c:pt>
                <c:pt idx="3">
                  <c:v>WT+Sb_I_+_8_6h</c:v>
                </c:pt>
                <c:pt idx="4">
                  <c:v>T Strepto_CEC_-_T2</c:v>
                </c:pt>
                <c:pt idx="5">
                  <c:v>WT_ CEC_O_7_6 h</c:v>
                </c:pt>
                <c:pt idx="6">
                  <c:v>T Sb Strepto_CEC_-_T3</c:v>
                </c:pt>
                <c:pt idx="7">
                  <c:v>WT+Sb_CEC_O_8_6 h</c:v>
                </c:pt>
                <c:pt idx="8">
                  <c:v>T Strepto_Col._-_T2</c:v>
                </c:pt>
                <c:pt idx="9">
                  <c:v>WT_ Col._O_7_6 h</c:v>
                </c:pt>
                <c:pt idx="10">
                  <c:v>T Sb Strepto_Col._-_T3</c:v>
                </c:pt>
                <c:pt idx="11">
                  <c:v>WT+Sb_Col._O_8_6 h</c:v>
                </c:pt>
              </c:strCache>
            </c:strRef>
          </c:cat>
          <c:val>
            <c:numRef>
              <c:f>'IFN 6h str'!$AQ$2:$AQ$13</c:f>
              <c:numCache>
                <c:formatCode>General</c:formatCode>
                <c:ptCount val="12"/>
                <c:pt idx="0">
                  <c:v>1.0</c:v>
                </c:pt>
                <c:pt idx="1">
                  <c:v>0.405033624712916</c:v>
                </c:pt>
                <c:pt idx="2">
                  <c:v>1.0</c:v>
                </c:pt>
                <c:pt idx="3">
                  <c:v>0.0343732073068134</c:v>
                </c:pt>
                <c:pt idx="4">
                  <c:v>1.0</c:v>
                </c:pt>
                <c:pt idx="5">
                  <c:v>0.278065331350794</c:v>
                </c:pt>
                <c:pt idx="6">
                  <c:v>1.0</c:v>
                </c:pt>
                <c:pt idx="7">
                  <c:v>26.60913164397843</c:v>
                </c:pt>
                <c:pt idx="8">
                  <c:v>1.0</c:v>
                </c:pt>
                <c:pt idx="9">
                  <c:v>1.499296518763308</c:v>
                </c:pt>
                <c:pt idx="10">
                  <c:v>1.0</c:v>
                </c:pt>
                <c:pt idx="11">
                  <c:v>0.5301220160452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593288"/>
        <c:axId val="507366312"/>
      </c:barChart>
      <c:catAx>
        <c:axId val="145932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507366312"/>
        <c:crossesAt val="0.01"/>
        <c:auto val="1"/>
        <c:lblAlgn val="ctr"/>
        <c:lblOffset val="100"/>
        <c:noMultiLvlLbl val="0"/>
      </c:catAx>
      <c:valAx>
        <c:axId val="507366312"/>
        <c:scaling>
          <c:logBase val="10.0"/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14593288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0765829886801805"/>
          <c:w val="0.887773975298672"/>
          <c:h val="0.7107200730343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10 6h Str'!$AS$1:$AT$1</c:f>
              <c:strCache>
                <c:ptCount val="1"/>
                <c:pt idx="0">
                  <c:v>IL10_I CEC Col_6h / T.STREPTO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2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4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6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8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0"/>
            <c:invertIfNegative val="0"/>
            <c:bubble3D val="0"/>
            <c:spPr>
              <a:noFill/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9BBB59"/>
              </a:solidFill>
              <a:ln>
                <a:solidFill>
                  <a:sysClr val="window" lastClr="FFFFFF">
                    <a:lumMod val="50000"/>
                  </a:sysClr>
                </a:solidFill>
              </a:ln>
            </c:spPr>
          </c:dPt>
          <c:cat>
            <c:strRef>
              <c:f>'IL10 6h Str'!$AM$2:$AM$13</c:f>
              <c:strCache>
                <c:ptCount val="12"/>
                <c:pt idx="0">
                  <c:v>T Strepto_I_-_T2</c:v>
                </c:pt>
                <c:pt idx="1">
                  <c:v>WT_I_+_7_6h</c:v>
                </c:pt>
                <c:pt idx="2">
                  <c:v>T Sb Strepto_I_-_T3</c:v>
                </c:pt>
                <c:pt idx="3">
                  <c:v>WT+Sb_I_+_8_6h</c:v>
                </c:pt>
                <c:pt idx="4">
                  <c:v>T Strepto_CEC_-_T2</c:v>
                </c:pt>
                <c:pt idx="5">
                  <c:v>WT_ CEC_O_7_6 h</c:v>
                </c:pt>
                <c:pt idx="6">
                  <c:v>T Sb Strepto_CEC_-_T3</c:v>
                </c:pt>
                <c:pt idx="7">
                  <c:v>WT+Sb_CEC_O_8_6 h</c:v>
                </c:pt>
                <c:pt idx="8">
                  <c:v>T Strepto_Col._-_T2</c:v>
                </c:pt>
                <c:pt idx="9">
                  <c:v>WT_ Col._O_7_6 h</c:v>
                </c:pt>
                <c:pt idx="10">
                  <c:v>T Sb Strepto_Col._-_T3</c:v>
                </c:pt>
                <c:pt idx="11">
                  <c:v>WT+Sb_Col._O_8_6 h</c:v>
                </c:pt>
              </c:strCache>
            </c:strRef>
          </c:cat>
          <c:val>
            <c:numRef>
              <c:f>'IL10 6h Str'!$AQ$2:$AQ$13</c:f>
              <c:numCache>
                <c:formatCode>General</c:formatCode>
                <c:ptCount val="12"/>
                <c:pt idx="0">
                  <c:v>1.0</c:v>
                </c:pt>
                <c:pt idx="1">
                  <c:v>53.78593123752336</c:v>
                </c:pt>
                <c:pt idx="2">
                  <c:v>1.0</c:v>
                </c:pt>
                <c:pt idx="3">
                  <c:v>0.0742027165154381</c:v>
                </c:pt>
                <c:pt idx="4">
                  <c:v>1.0</c:v>
                </c:pt>
                <c:pt idx="5">
                  <c:v>1.067188370242186</c:v>
                </c:pt>
                <c:pt idx="6">
                  <c:v>1.0</c:v>
                </c:pt>
                <c:pt idx="7">
                  <c:v>6.116289069578841</c:v>
                </c:pt>
                <c:pt idx="8">
                  <c:v>1.0</c:v>
                </c:pt>
                <c:pt idx="9">
                  <c:v>1.103651277426838</c:v>
                </c:pt>
                <c:pt idx="10">
                  <c:v>1.0</c:v>
                </c:pt>
                <c:pt idx="11">
                  <c:v>0.5097536429402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22887176"/>
        <c:axId val="484938232"/>
      </c:barChart>
      <c:catAx>
        <c:axId val="4228871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484938232"/>
        <c:crossesAt val="0.01"/>
        <c:auto val="1"/>
        <c:lblAlgn val="ctr"/>
        <c:lblOffset val="100"/>
        <c:noMultiLvlLbl val="0"/>
      </c:catAx>
      <c:valAx>
        <c:axId val="484938232"/>
        <c:scaling>
          <c:logBase val="10.0"/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/>
            </a:pPr>
            <a:endParaRPr lang="fr-FR"/>
          </a:p>
        </c:txPr>
        <c:crossAx val="422887176"/>
        <c:crosses val="autoZero"/>
        <c:crossBetween val="between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1635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300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377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2267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3626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5740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4590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2545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6901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3682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89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1856B-AF02-3848-A24C-5FD752873328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F276DB-7D32-2B46-A91F-AA0204E4623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773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9" Type="http://schemas.openxmlformats.org/officeDocument/2006/relationships/chart" Target="../charts/chart8.xml"/><Relationship Id="rId3" Type="http://schemas.openxmlformats.org/officeDocument/2006/relationships/chart" Target="../charts/chart2.xml"/><Relationship Id="rId6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74342" y="299702"/>
            <a:ext cx="3237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FN-</a:t>
            </a:r>
            <a:r>
              <a:rPr lang="fr-FR" sz="1200" b="1" dirty="0" smtClean="0">
                <a:latin typeface="Symbol" charset="2"/>
                <a:cs typeface="Symbol" charset="2"/>
              </a:rPr>
              <a:t>g </a:t>
            </a:r>
            <a:r>
              <a:rPr lang="fr-FR" sz="1200" b="1" dirty="0">
                <a:latin typeface="Arial"/>
                <a:cs typeface="Arial"/>
              </a:rPr>
              <a:t>Relative </a:t>
            </a:r>
            <a:r>
              <a:rPr lang="fr-FR" sz="1200" b="1" dirty="0" err="1">
                <a:latin typeface="Arial"/>
                <a:cs typeface="Arial"/>
              </a:rPr>
              <a:t>mRN</a:t>
            </a:r>
            <a:r>
              <a:rPr lang="fr-FR" sz="1200" b="1" dirty="0">
                <a:latin typeface="Arial"/>
                <a:cs typeface="Arial"/>
              </a:rPr>
              <a:t> (</a:t>
            </a:r>
            <a:r>
              <a:rPr lang="fr-FR" sz="1200" b="1" dirty="0" err="1">
                <a:latin typeface="Arial"/>
                <a:cs typeface="Arial"/>
              </a:rPr>
              <a:t>fold</a:t>
            </a:r>
            <a:r>
              <a:rPr lang="fr-FR" sz="1200" b="1" dirty="0">
                <a:latin typeface="Arial"/>
                <a:cs typeface="Arial"/>
              </a:rPr>
              <a:t> change x 10</a:t>
            </a:r>
            <a:r>
              <a:rPr lang="fr-FR" sz="1200" b="1" baseline="30000" dirty="0">
                <a:latin typeface="Arial"/>
                <a:cs typeface="Arial"/>
              </a:rPr>
              <a:t>-2</a:t>
            </a:r>
            <a:r>
              <a:rPr lang="fr-FR" sz="1200" b="1" dirty="0" smtClean="0">
                <a:latin typeface="Arial"/>
                <a:cs typeface="Arial"/>
              </a:rPr>
              <a:t>)</a:t>
            </a:r>
            <a:endParaRPr lang="fr-FR" sz="1200" b="1" dirty="0">
              <a:latin typeface="Arial"/>
              <a:cs typeface="Arial"/>
            </a:endParaRPr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2378097"/>
              </p:ext>
            </p:extLst>
          </p:nvPr>
        </p:nvGraphicFramePr>
        <p:xfrm>
          <a:off x="422462" y="567773"/>
          <a:ext cx="3451209" cy="1691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41067" y="1610621"/>
            <a:ext cx="270251" cy="231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51172" y="1339516"/>
            <a:ext cx="355837" cy="231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332421" y="1073363"/>
            <a:ext cx="412893" cy="231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55552" y="801629"/>
            <a:ext cx="412893" cy="231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358576" y="570372"/>
            <a:ext cx="41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cxnSp>
        <p:nvCxnSpPr>
          <p:cNvPr id="12" name="Connecteur droit 11"/>
          <p:cNvCxnSpPr/>
          <p:nvPr/>
        </p:nvCxnSpPr>
        <p:spPr>
          <a:xfrm>
            <a:off x="2839658" y="697092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452621" y="1851306"/>
            <a:ext cx="235912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493917" y="1869164"/>
            <a:ext cx="270251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832957" y="1861015"/>
            <a:ext cx="270251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134484" y="1860622"/>
            <a:ext cx="235912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3067143" y="1835448"/>
            <a:ext cx="235912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198449" y="1830322"/>
            <a:ext cx="235912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625330" y="1839391"/>
            <a:ext cx="235912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662614" y="1855188"/>
            <a:ext cx="407083" cy="2315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1033054" y="1939266"/>
            <a:ext cx="817426" cy="3077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2069697" y="1876550"/>
            <a:ext cx="697802" cy="3077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3029994" y="1873851"/>
            <a:ext cx="620557" cy="3077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graphicFrame>
        <p:nvGraphicFramePr>
          <p:cNvPr id="24" name="Graphique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712448"/>
              </p:ext>
            </p:extLst>
          </p:nvPr>
        </p:nvGraphicFramePr>
        <p:xfrm>
          <a:off x="360868" y="2211528"/>
          <a:ext cx="3632485" cy="1875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5" name="ZoneTexte 24"/>
          <p:cNvSpPr txBox="1"/>
          <p:nvPr/>
        </p:nvSpPr>
        <p:spPr>
          <a:xfrm>
            <a:off x="354513" y="3266505"/>
            <a:ext cx="278441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312186" y="2965522"/>
            <a:ext cx="366619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05134" y="2704284"/>
            <a:ext cx="425404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296779" y="2445125"/>
            <a:ext cx="425404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288759" y="2195573"/>
            <a:ext cx="425404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853898" y="3428321"/>
            <a:ext cx="278441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1004557" y="3428321"/>
            <a:ext cx="278441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2610575" y="3438101"/>
            <a:ext cx="419419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1033369" y="3562146"/>
            <a:ext cx="842196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2232561" y="3540659"/>
            <a:ext cx="718946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127796" y="3539158"/>
            <a:ext cx="639361" cy="219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3149294" y="3422623"/>
            <a:ext cx="243061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2285499" y="3421161"/>
            <a:ext cx="243061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781250" y="3419017"/>
            <a:ext cx="282853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FF0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1147867" y="3419017"/>
            <a:ext cx="419419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625343" y="3431679"/>
            <a:ext cx="282853" cy="219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008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graphicFrame>
        <p:nvGraphicFramePr>
          <p:cNvPr id="43" name="Graphique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1412089"/>
              </p:ext>
            </p:extLst>
          </p:nvPr>
        </p:nvGraphicFramePr>
        <p:xfrm>
          <a:off x="374599" y="3769382"/>
          <a:ext cx="3633368" cy="2076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4" name="ZoneTexte 43"/>
          <p:cNvSpPr txBox="1"/>
          <p:nvPr/>
        </p:nvSpPr>
        <p:spPr>
          <a:xfrm>
            <a:off x="425578" y="4804577"/>
            <a:ext cx="281225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356178" y="4516294"/>
            <a:ext cx="370285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304401" y="4261376"/>
            <a:ext cx="429658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300362" y="4008265"/>
            <a:ext cx="429658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291854" y="3773039"/>
            <a:ext cx="429658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914895" y="5042077"/>
            <a:ext cx="850617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128525" y="4970010"/>
            <a:ext cx="281225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2125083" y="5025046"/>
            <a:ext cx="726135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3206163" y="5035913"/>
            <a:ext cx="645755" cy="201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118639" y="4973355"/>
            <a:ext cx="245492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869337" y="4957382"/>
            <a:ext cx="285682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FF0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608539" y="4960381"/>
            <a:ext cx="285682" cy="22160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008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2038727" y="4949137"/>
            <a:ext cx="423613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2595856" y="4982561"/>
            <a:ext cx="281225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603645" y="4965849"/>
            <a:ext cx="281225" cy="201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cxnSp>
        <p:nvCxnSpPr>
          <p:cNvPr id="61" name="Connecteur droit 60"/>
          <p:cNvCxnSpPr/>
          <p:nvPr/>
        </p:nvCxnSpPr>
        <p:spPr>
          <a:xfrm flipH="1">
            <a:off x="653310" y="1522899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>
            <a:off x="4123222" y="638633"/>
            <a:ext cx="860332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>
                <a:latin typeface="Arial"/>
                <a:cs typeface="Arial"/>
              </a:rPr>
              <a:t>1</a:t>
            </a:r>
            <a:r>
              <a:rPr lang="fr-FR" sz="1200" b="1" dirty="0" smtClean="0">
                <a:latin typeface="Arial"/>
                <a:cs typeface="Arial"/>
              </a:rPr>
              <a:t>5 min PI 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4142973" y="2257208"/>
            <a:ext cx="860201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45 min PI 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4123222" y="3871404"/>
            <a:ext cx="891383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90 min PI 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5600745" y="348019"/>
            <a:ext cx="3117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 IL-10 relative mRNA (fold change x 10</a:t>
            </a:r>
            <a:r>
              <a:rPr lang="en-US" sz="1200" b="1" baseline="30000" dirty="0" smtClean="0">
                <a:latin typeface="Arial"/>
                <a:cs typeface="Arial"/>
              </a:rPr>
              <a:t>-2</a:t>
            </a:r>
            <a:r>
              <a:rPr lang="en-US" sz="1200" b="1" dirty="0" smtClean="0">
                <a:latin typeface="Arial"/>
                <a:cs typeface="Arial"/>
              </a:rPr>
              <a:t>) </a:t>
            </a:r>
            <a:endParaRPr lang="en-US" sz="1200" b="1" dirty="0">
              <a:latin typeface="Arial"/>
              <a:cs typeface="Arial"/>
            </a:endParaRPr>
          </a:p>
        </p:txBody>
      </p:sp>
      <p:graphicFrame>
        <p:nvGraphicFramePr>
          <p:cNvPr id="68" name="Graphique 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4175853"/>
              </p:ext>
            </p:extLst>
          </p:nvPr>
        </p:nvGraphicFramePr>
        <p:xfrm>
          <a:off x="5251457" y="518879"/>
          <a:ext cx="3435693" cy="2189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0" name="ZoneTexte 69"/>
          <p:cNvSpPr txBox="1"/>
          <p:nvPr/>
        </p:nvSpPr>
        <p:spPr>
          <a:xfrm>
            <a:off x="5279817" y="1718117"/>
            <a:ext cx="270251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5198876" y="1406511"/>
            <a:ext cx="355837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5172626" y="1123024"/>
            <a:ext cx="412893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5172096" y="805940"/>
            <a:ext cx="412893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74" name="ZoneTexte 73"/>
          <p:cNvSpPr txBox="1"/>
          <p:nvPr/>
        </p:nvSpPr>
        <p:spPr>
          <a:xfrm>
            <a:off x="5164076" y="565159"/>
            <a:ext cx="412893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75" name="Rectangle 74"/>
          <p:cNvSpPr/>
          <p:nvPr/>
        </p:nvSpPr>
        <p:spPr>
          <a:xfrm>
            <a:off x="6328297" y="1883633"/>
            <a:ext cx="270251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5675800" y="1883633"/>
            <a:ext cx="270251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5926525" y="1883240"/>
            <a:ext cx="235912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7897952" y="1887131"/>
            <a:ext cx="235912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8334406" y="1894880"/>
            <a:ext cx="235912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7007420" y="1888355"/>
            <a:ext cx="235912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7451128" y="1884724"/>
            <a:ext cx="235912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6488524" y="1886590"/>
            <a:ext cx="407083" cy="2203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5723491" y="1953889"/>
            <a:ext cx="817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6906064" y="1931383"/>
            <a:ext cx="697802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7923421" y="1917157"/>
            <a:ext cx="620557" cy="22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graphicFrame>
        <p:nvGraphicFramePr>
          <p:cNvPr id="86" name="Graphique 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5648130"/>
              </p:ext>
            </p:extLst>
          </p:nvPr>
        </p:nvGraphicFramePr>
        <p:xfrm>
          <a:off x="5281232" y="2201203"/>
          <a:ext cx="3397870" cy="15203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7" name="ZoneTexte 86"/>
          <p:cNvSpPr txBox="1"/>
          <p:nvPr/>
        </p:nvSpPr>
        <p:spPr>
          <a:xfrm>
            <a:off x="6004678" y="3594650"/>
            <a:ext cx="833856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cxnSp>
        <p:nvCxnSpPr>
          <p:cNvPr id="88" name="Connecteur droit 87"/>
          <p:cNvCxnSpPr/>
          <p:nvPr/>
        </p:nvCxnSpPr>
        <p:spPr>
          <a:xfrm flipH="1">
            <a:off x="6942576" y="2307413"/>
            <a:ext cx="6422" cy="13173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Connecteur droit 88"/>
          <p:cNvCxnSpPr/>
          <p:nvPr/>
        </p:nvCxnSpPr>
        <p:spPr>
          <a:xfrm>
            <a:off x="7738883" y="2309260"/>
            <a:ext cx="0" cy="13324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ZoneTexte 89"/>
          <p:cNvSpPr txBox="1"/>
          <p:nvPr/>
        </p:nvSpPr>
        <p:spPr>
          <a:xfrm>
            <a:off x="5307891" y="3240044"/>
            <a:ext cx="275684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91" name="ZoneTexte 90"/>
          <p:cNvSpPr txBox="1"/>
          <p:nvPr/>
        </p:nvSpPr>
        <p:spPr>
          <a:xfrm>
            <a:off x="5222403" y="3007259"/>
            <a:ext cx="362989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92" name="ZoneTexte 91"/>
          <p:cNvSpPr txBox="1"/>
          <p:nvPr/>
        </p:nvSpPr>
        <p:spPr>
          <a:xfrm>
            <a:off x="5195075" y="2742232"/>
            <a:ext cx="421192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93" name="ZoneTexte 92"/>
          <p:cNvSpPr txBox="1"/>
          <p:nvPr/>
        </p:nvSpPr>
        <p:spPr>
          <a:xfrm>
            <a:off x="5194922" y="2432497"/>
            <a:ext cx="421192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94" name="ZoneTexte 93"/>
          <p:cNvSpPr txBox="1"/>
          <p:nvPr/>
        </p:nvSpPr>
        <p:spPr>
          <a:xfrm>
            <a:off x="5190730" y="2204001"/>
            <a:ext cx="421192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95" name="ZoneTexte 94"/>
          <p:cNvSpPr txBox="1"/>
          <p:nvPr/>
        </p:nvSpPr>
        <p:spPr>
          <a:xfrm>
            <a:off x="7076341" y="3582054"/>
            <a:ext cx="711828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96" name="ZoneTexte 95"/>
          <p:cNvSpPr txBox="1"/>
          <p:nvPr/>
        </p:nvSpPr>
        <p:spPr>
          <a:xfrm>
            <a:off x="7983887" y="3564428"/>
            <a:ext cx="633031" cy="222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graphicFrame>
        <p:nvGraphicFramePr>
          <p:cNvPr id="97" name="Graphique 9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2226807"/>
              </p:ext>
            </p:extLst>
          </p:nvPr>
        </p:nvGraphicFramePr>
        <p:xfrm>
          <a:off x="5313369" y="3799112"/>
          <a:ext cx="3467677" cy="1774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9" name="Rectangle 98"/>
          <p:cNvSpPr/>
          <p:nvPr/>
        </p:nvSpPr>
        <p:spPr>
          <a:xfrm>
            <a:off x="6703740" y="3448660"/>
            <a:ext cx="275684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00" name="Rectangle 99"/>
          <p:cNvSpPr/>
          <p:nvPr/>
        </p:nvSpPr>
        <p:spPr>
          <a:xfrm>
            <a:off x="8303779" y="3440721"/>
            <a:ext cx="240654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01" name="Rectangle 100"/>
          <p:cNvSpPr/>
          <p:nvPr/>
        </p:nvSpPr>
        <p:spPr>
          <a:xfrm>
            <a:off x="7401846" y="3433039"/>
            <a:ext cx="415266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7914291" y="3432379"/>
            <a:ext cx="240654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7092827" y="3433033"/>
            <a:ext cx="240654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4" name="Rectangle 103"/>
          <p:cNvSpPr/>
          <p:nvPr/>
        </p:nvSpPr>
        <p:spPr>
          <a:xfrm>
            <a:off x="5736949" y="3430889"/>
            <a:ext cx="280052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FF0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5" name="Rectangle 104"/>
          <p:cNvSpPr/>
          <p:nvPr/>
        </p:nvSpPr>
        <p:spPr>
          <a:xfrm>
            <a:off x="6049202" y="3437240"/>
            <a:ext cx="415266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6" name="Rectangle 105"/>
          <p:cNvSpPr/>
          <p:nvPr/>
        </p:nvSpPr>
        <p:spPr>
          <a:xfrm>
            <a:off x="6500607" y="3439318"/>
            <a:ext cx="280052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008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5888599" y="3448660"/>
            <a:ext cx="275684" cy="222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5347568" y="4792636"/>
            <a:ext cx="270251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5258963" y="4538113"/>
            <a:ext cx="355837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5217008" y="4267176"/>
            <a:ext cx="412893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 smtClean="0">
                <a:latin typeface="Arial"/>
                <a:cs typeface="Arial"/>
              </a:rPr>
              <a:t>2</a:t>
            </a:r>
            <a:endParaRPr lang="fr-FR" sz="1200" baseline="30000" dirty="0">
              <a:latin typeface="Arial"/>
              <a:cs typeface="Arial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5225433" y="4028616"/>
            <a:ext cx="412893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3</a:t>
            </a:r>
          </a:p>
        </p:txBody>
      </p:sp>
      <p:sp>
        <p:nvSpPr>
          <p:cNvPr id="112" name="ZoneTexte 111"/>
          <p:cNvSpPr txBox="1"/>
          <p:nvPr/>
        </p:nvSpPr>
        <p:spPr>
          <a:xfrm>
            <a:off x="5218081" y="3776237"/>
            <a:ext cx="558036" cy="2338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r>
              <a:rPr lang="fr-FR" sz="1200" baseline="30000" dirty="0">
                <a:latin typeface="Arial"/>
                <a:cs typeface="Arial"/>
              </a:rPr>
              <a:t>4</a:t>
            </a:r>
          </a:p>
        </p:txBody>
      </p:sp>
      <p:sp>
        <p:nvSpPr>
          <p:cNvPr id="115" name="ZoneTexte 114"/>
          <p:cNvSpPr txBox="1"/>
          <p:nvPr/>
        </p:nvSpPr>
        <p:spPr>
          <a:xfrm>
            <a:off x="5886121" y="5060570"/>
            <a:ext cx="817426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Intestine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16" name="ZoneTexte 115"/>
          <p:cNvSpPr txBox="1"/>
          <p:nvPr/>
        </p:nvSpPr>
        <p:spPr>
          <a:xfrm>
            <a:off x="6931222" y="5081639"/>
            <a:ext cx="697802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Arial"/>
                <a:cs typeface="Arial"/>
              </a:rPr>
              <a:t>Cecum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6038066" y="5012702"/>
            <a:ext cx="270251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18" name="ZoneTexte 117"/>
          <p:cNvSpPr txBox="1"/>
          <p:nvPr/>
        </p:nvSpPr>
        <p:spPr>
          <a:xfrm>
            <a:off x="7953962" y="5096850"/>
            <a:ext cx="620557" cy="233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Colon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119" name="Rectangle 118"/>
          <p:cNvSpPr/>
          <p:nvPr/>
        </p:nvSpPr>
        <p:spPr>
          <a:xfrm>
            <a:off x="7947668" y="5001453"/>
            <a:ext cx="235912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20" name="Rectangle 119"/>
          <p:cNvSpPr/>
          <p:nvPr/>
        </p:nvSpPr>
        <p:spPr>
          <a:xfrm>
            <a:off x="5784858" y="5010646"/>
            <a:ext cx="274534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FF0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21" name="Rectangle 120"/>
          <p:cNvSpPr/>
          <p:nvPr/>
        </p:nvSpPr>
        <p:spPr>
          <a:xfrm>
            <a:off x="6518502" y="5013784"/>
            <a:ext cx="274534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>
                <a:solidFill>
                  <a:srgbClr val="008000"/>
                </a:solidFill>
                <a:latin typeface="Arial"/>
                <a:cs typeface="Arial"/>
              </a:rPr>
              <a:t>+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6917734" y="5005231"/>
            <a:ext cx="407083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FF0000"/>
                </a:solidFill>
                <a:latin typeface="Arial"/>
                <a:cs typeface="Arial"/>
              </a:rPr>
              <a:t>«-»</a:t>
            </a:r>
            <a:endParaRPr lang="fr-FR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123" name="Rectangle 122"/>
          <p:cNvSpPr/>
          <p:nvPr/>
        </p:nvSpPr>
        <p:spPr>
          <a:xfrm>
            <a:off x="7450059" y="5009418"/>
            <a:ext cx="270251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24" name="Rectangle 123"/>
          <p:cNvSpPr/>
          <p:nvPr/>
        </p:nvSpPr>
        <p:spPr>
          <a:xfrm>
            <a:off x="8404295" y="5004287"/>
            <a:ext cx="270251" cy="2338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0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220646" y="27801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>
                <a:latin typeface="Arial"/>
                <a:cs typeface="Arial"/>
              </a:rPr>
              <a:t>Figure S4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279392" y="310720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30" name="ZoneTexte 129"/>
          <p:cNvSpPr txBox="1"/>
          <p:nvPr/>
        </p:nvSpPr>
        <p:spPr>
          <a:xfrm>
            <a:off x="5258226" y="369157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B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-959073" y="-2944653"/>
            <a:ext cx="348043" cy="962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cxnSp>
        <p:nvCxnSpPr>
          <p:cNvPr id="133" name="Connecteur droit 132"/>
          <p:cNvCxnSpPr/>
          <p:nvPr/>
        </p:nvCxnSpPr>
        <p:spPr>
          <a:xfrm>
            <a:off x="2014523" y="682372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Connecteur droit 133"/>
          <p:cNvCxnSpPr/>
          <p:nvPr/>
        </p:nvCxnSpPr>
        <p:spPr>
          <a:xfrm>
            <a:off x="2992058" y="2328504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Connecteur droit 134"/>
          <p:cNvCxnSpPr/>
          <p:nvPr/>
        </p:nvCxnSpPr>
        <p:spPr>
          <a:xfrm>
            <a:off x="2116793" y="2330496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Connecteur droit 135"/>
          <p:cNvCxnSpPr/>
          <p:nvPr/>
        </p:nvCxnSpPr>
        <p:spPr>
          <a:xfrm flipH="1">
            <a:off x="688740" y="3129243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7" name="Rectangle 136"/>
          <p:cNvSpPr/>
          <p:nvPr/>
        </p:nvSpPr>
        <p:spPr>
          <a:xfrm>
            <a:off x="3627539" y="3432971"/>
            <a:ext cx="235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baseline="30000" dirty="0" smtClean="0">
                <a:solidFill>
                  <a:srgbClr val="008000"/>
                </a:solidFill>
                <a:latin typeface="Arial"/>
                <a:cs typeface="Arial"/>
              </a:rPr>
              <a:t>-</a:t>
            </a:r>
            <a:endParaRPr lang="fr-FR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cxnSp>
        <p:nvCxnSpPr>
          <p:cNvPr id="138" name="Connecteur droit 137"/>
          <p:cNvCxnSpPr/>
          <p:nvPr/>
        </p:nvCxnSpPr>
        <p:spPr>
          <a:xfrm flipH="1">
            <a:off x="680385" y="4658391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" name="Connecteur droit 138"/>
          <p:cNvCxnSpPr/>
          <p:nvPr/>
        </p:nvCxnSpPr>
        <p:spPr>
          <a:xfrm>
            <a:off x="2866733" y="3907788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Connecteur droit 139"/>
          <p:cNvCxnSpPr/>
          <p:nvPr/>
        </p:nvCxnSpPr>
        <p:spPr>
          <a:xfrm>
            <a:off x="1882853" y="3926492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1" name="Grouper 140"/>
          <p:cNvGrpSpPr/>
          <p:nvPr/>
        </p:nvGrpSpPr>
        <p:grpSpPr>
          <a:xfrm>
            <a:off x="313714" y="5324486"/>
            <a:ext cx="3585565" cy="1953713"/>
            <a:chOff x="329789" y="4705260"/>
            <a:chExt cx="3657635" cy="2679185"/>
          </a:xfrm>
        </p:grpSpPr>
        <p:graphicFrame>
          <p:nvGraphicFramePr>
            <p:cNvPr id="142" name="Graphique 1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8274481"/>
                </p:ext>
              </p:extLst>
            </p:nvPr>
          </p:nvGraphicFramePr>
          <p:xfrm>
            <a:off x="416698" y="4705260"/>
            <a:ext cx="3570726" cy="26791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43" name="ZoneTexte 142"/>
            <p:cNvSpPr txBox="1"/>
            <p:nvPr/>
          </p:nvSpPr>
          <p:spPr>
            <a:xfrm>
              <a:off x="425801" y="6010101"/>
              <a:ext cx="196132" cy="20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</a:t>
              </a:r>
              <a:endParaRPr lang="fr-FR" sz="1200" dirty="0"/>
            </a:p>
          </p:txBody>
        </p:sp>
        <p:sp>
          <p:nvSpPr>
            <p:cNvPr id="144" name="ZoneTexte 143"/>
            <p:cNvSpPr txBox="1"/>
            <p:nvPr/>
          </p:nvSpPr>
          <p:spPr>
            <a:xfrm>
              <a:off x="354758" y="5711924"/>
              <a:ext cx="254372" cy="20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endParaRPr lang="fr-FR" sz="1200" dirty="0"/>
            </a:p>
          </p:txBody>
        </p:sp>
        <p:sp>
          <p:nvSpPr>
            <p:cNvPr id="145" name="ZoneTexte 144"/>
            <p:cNvSpPr txBox="1"/>
            <p:nvPr/>
          </p:nvSpPr>
          <p:spPr>
            <a:xfrm>
              <a:off x="341339" y="5361891"/>
              <a:ext cx="293199" cy="20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 smtClean="0"/>
                <a:t>2</a:t>
              </a:r>
              <a:endParaRPr lang="fr-FR" sz="1200" baseline="30000" dirty="0"/>
            </a:p>
          </p:txBody>
        </p:sp>
        <p:sp>
          <p:nvSpPr>
            <p:cNvPr id="146" name="ZoneTexte 145"/>
            <p:cNvSpPr txBox="1"/>
            <p:nvPr/>
          </p:nvSpPr>
          <p:spPr>
            <a:xfrm>
              <a:off x="329789" y="5040419"/>
              <a:ext cx="293199" cy="204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/>
                <a:t>3</a:t>
              </a:r>
            </a:p>
          </p:txBody>
        </p:sp>
        <p:sp>
          <p:nvSpPr>
            <p:cNvPr id="147" name="ZoneTexte 146"/>
            <p:cNvSpPr txBox="1"/>
            <p:nvPr/>
          </p:nvSpPr>
          <p:spPr>
            <a:xfrm>
              <a:off x="343411" y="4744137"/>
              <a:ext cx="384919" cy="268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/>
                <a:t>4</a:t>
              </a:r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958267" y="6339821"/>
              <a:ext cx="256161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>
                  <a:solidFill>
                    <a:srgbClr val="FF0000"/>
                  </a:solidFill>
                </a:rPr>
                <a:t>+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50" name="Rectangle 149"/>
            <p:cNvSpPr/>
            <p:nvPr/>
          </p:nvSpPr>
          <p:spPr>
            <a:xfrm>
              <a:off x="3572663" y="6379562"/>
              <a:ext cx="257486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008000"/>
                  </a:solidFill>
                </a:rPr>
                <a:t>0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3068651" y="6369126"/>
              <a:ext cx="257486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FF0000"/>
                  </a:solidFill>
                </a:rPr>
                <a:t>0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2556043" y="6357867"/>
              <a:ext cx="257486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008000"/>
                  </a:solidFill>
                </a:rPr>
                <a:t>0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2039369" y="6352484"/>
              <a:ext cx="257486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FF0000"/>
                  </a:solidFill>
                </a:rPr>
                <a:t>0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54" name="Rectangle 153"/>
            <p:cNvSpPr/>
            <p:nvPr/>
          </p:nvSpPr>
          <p:spPr>
            <a:xfrm>
              <a:off x="1474824" y="6365150"/>
              <a:ext cx="256161" cy="2688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>
                  <a:solidFill>
                    <a:srgbClr val="008000"/>
                  </a:solidFill>
                </a:rPr>
                <a:t>+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155" name="ZoneTexte 154"/>
            <p:cNvSpPr txBox="1"/>
            <p:nvPr/>
          </p:nvSpPr>
          <p:spPr>
            <a:xfrm>
              <a:off x="994568" y="6398300"/>
              <a:ext cx="735836" cy="268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Intestine</a:t>
              </a:r>
              <a:endParaRPr lang="fr-FR" sz="1200" b="1" dirty="0"/>
            </a:p>
          </p:txBody>
        </p:sp>
        <p:sp>
          <p:nvSpPr>
            <p:cNvPr id="156" name="ZoneTexte 155"/>
            <p:cNvSpPr txBox="1"/>
            <p:nvPr/>
          </p:nvSpPr>
          <p:spPr>
            <a:xfrm>
              <a:off x="2077821" y="6412003"/>
              <a:ext cx="331612" cy="148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/>
                <a:t>Cecum</a:t>
              </a:r>
              <a:endParaRPr lang="fr-FR" sz="1200" b="1" dirty="0"/>
            </a:p>
          </p:txBody>
        </p:sp>
        <p:sp>
          <p:nvSpPr>
            <p:cNvPr id="157" name="ZoneTexte 156"/>
            <p:cNvSpPr txBox="1"/>
            <p:nvPr/>
          </p:nvSpPr>
          <p:spPr>
            <a:xfrm>
              <a:off x="3259897" y="6454338"/>
              <a:ext cx="299006" cy="148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Colon</a:t>
              </a:r>
              <a:endParaRPr lang="fr-FR" sz="1200" b="1" dirty="0"/>
            </a:p>
          </p:txBody>
        </p:sp>
        <p:cxnSp>
          <p:nvCxnSpPr>
            <p:cNvPr id="158" name="Connecteur droit 157"/>
            <p:cNvCxnSpPr>
              <a:cxnSpLocks/>
            </p:cNvCxnSpPr>
            <p:nvPr/>
          </p:nvCxnSpPr>
          <p:spPr>
            <a:xfrm>
              <a:off x="2796630" y="4892126"/>
              <a:ext cx="0" cy="17279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cteur droit 158"/>
            <p:cNvCxnSpPr>
              <a:cxnSpLocks/>
            </p:cNvCxnSpPr>
            <p:nvPr/>
          </p:nvCxnSpPr>
          <p:spPr>
            <a:xfrm>
              <a:off x="1733085" y="4900414"/>
              <a:ext cx="0" cy="17279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0" name="Connecteur droit 159"/>
          <p:cNvCxnSpPr/>
          <p:nvPr/>
        </p:nvCxnSpPr>
        <p:spPr>
          <a:xfrm>
            <a:off x="6801938" y="690728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" name="Connecteur droit 160"/>
          <p:cNvCxnSpPr/>
          <p:nvPr/>
        </p:nvCxnSpPr>
        <p:spPr>
          <a:xfrm>
            <a:off x="7681223" y="692720"/>
            <a:ext cx="0" cy="1323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Connecteur droit 161"/>
          <p:cNvCxnSpPr/>
          <p:nvPr/>
        </p:nvCxnSpPr>
        <p:spPr>
          <a:xfrm flipH="1">
            <a:off x="5451090" y="1566671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4" name="Connecteur droit 163"/>
          <p:cNvCxnSpPr/>
          <p:nvPr/>
        </p:nvCxnSpPr>
        <p:spPr>
          <a:xfrm flipH="1">
            <a:off x="5511585" y="3139591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Connecteur droit 164"/>
          <p:cNvCxnSpPr/>
          <p:nvPr/>
        </p:nvCxnSpPr>
        <p:spPr>
          <a:xfrm flipH="1">
            <a:off x="6735711" y="3922113"/>
            <a:ext cx="6422" cy="13173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Connecteur droit 165"/>
          <p:cNvCxnSpPr/>
          <p:nvPr/>
        </p:nvCxnSpPr>
        <p:spPr>
          <a:xfrm flipH="1">
            <a:off x="7706901" y="3932461"/>
            <a:ext cx="6422" cy="13173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Connecteur droit 166"/>
          <p:cNvCxnSpPr/>
          <p:nvPr/>
        </p:nvCxnSpPr>
        <p:spPr>
          <a:xfrm flipH="1">
            <a:off x="5538660" y="4712511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8" name="Grouper 167"/>
          <p:cNvGrpSpPr/>
          <p:nvPr/>
        </p:nvGrpSpPr>
        <p:grpSpPr>
          <a:xfrm>
            <a:off x="5259893" y="5361260"/>
            <a:ext cx="3538184" cy="1471044"/>
            <a:chOff x="5353028" y="254516"/>
            <a:chExt cx="3645395" cy="2022599"/>
          </a:xfrm>
        </p:grpSpPr>
        <p:graphicFrame>
          <p:nvGraphicFramePr>
            <p:cNvPr id="169" name="Graphique 16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00507147"/>
                </p:ext>
              </p:extLst>
            </p:nvPr>
          </p:nvGraphicFramePr>
          <p:xfrm>
            <a:off x="5441590" y="304745"/>
            <a:ext cx="3556833" cy="19404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cxnSp>
          <p:nvCxnSpPr>
            <p:cNvPr id="170" name="Connecteur droit 169"/>
            <p:cNvCxnSpPr/>
            <p:nvPr/>
          </p:nvCxnSpPr>
          <p:spPr>
            <a:xfrm>
              <a:off x="6743243" y="421184"/>
              <a:ext cx="0" cy="18359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cteur droit 170"/>
            <p:cNvCxnSpPr/>
            <p:nvPr/>
          </p:nvCxnSpPr>
          <p:spPr>
            <a:xfrm>
              <a:off x="7786878" y="415869"/>
              <a:ext cx="0" cy="179999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ZoneTexte 171"/>
            <p:cNvSpPr txBox="1"/>
            <p:nvPr/>
          </p:nvSpPr>
          <p:spPr>
            <a:xfrm>
              <a:off x="5436096" y="1530635"/>
              <a:ext cx="200074" cy="210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</a:t>
              </a:r>
              <a:endParaRPr lang="fr-FR" sz="1200" dirty="0"/>
            </a:p>
          </p:txBody>
        </p:sp>
        <p:sp>
          <p:nvSpPr>
            <p:cNvPr id="173" name="ZoneTexte 172"/>
            <p:cNvSpPr txBox="1"/>
            <p:nvPr/>
          </p:nvSpPr>
          <p:spPr>
            <a:xfrm>
              <a:off x="5381104" y="1217203"/>
              <a:ext cx="259485" cy="210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endParaRPr lang="fr-FR" sz="1200" dirty="0"/>
            </a:p>
          </p:txBody>
        </p:sp>
        <p:sp>
          <p:nvSpPr>
            <p:cNvPr id="174" name="ZoneTexte 173"/>
            <p:cNvSpPr txBox="1"/>
            <p:nvPr/>
          </p:nvSpPr>
          <p:spPr>
            <a:xfrm>
              <a:off x="5364088" y="889468"/>
              <a:ext cx="299092" cy="2109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 smtClean="0"/>
                <a:t>2</a:t>
              </a:r>
              <a:endParaRPr lang="fr-FR" sz="1200" baseline="30000" dirty="0"/>
            </a:p>
          </p:txBody>
        </p:sp>
        <p:sp>
          <p:nvSpPr>
            <p:cNvPr id="175" name="ZoneTexte 174"/>
            <p:cNvSpPr txBox="1"/>
            <p:nvPr/>
          </p:nvSpPr>
          <p:spPr>
            <a:xfrm>
              <a:off x="5353028" y="565667"/>
              <a:ext cx="299092" cy="2109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/>
                <a:t>3</a:t>
              </a:r>
            </a:p>
          </p:txBody>
        </p:sp>
        <p:sp>
          <p:nvSpPr>
            <p:cNvPr id="176" name="ZoneTexte 175"/>
            <p:cNvSpPr txBox="1"/>
            <p:nvPr/>
          </p:nvSpPr>
          <p:spPr>
            <a:xfrm>
              <a:off x="5359896" y="254516"/>
              <a:ext cx="392656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</a:t>
              </a:r>
              <a:r>
                <a:rPr lang="fr-FR" sz="1200" baseline="30000" dirty="0"/>
                <a:t>4</a:t>
              </a:r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5847169" y="2000116"/>
              <a:ext cx="750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Intestine</a:t>
              </a:r>
              <a:endParaRPr lang="fr-FR" sz="1200" b="1" dirty="0"/>
            </a:p>
          </p:txBody>
        </p:sp>
        <p:sp>
          <p:nvSpPr>
            <p:cNvPr id="178" name="ZoneTexte 177"/>
            <p:cNvSpPr txBox="1"/>
            <p:nvPr/>
          </p:nvSpPr>
          <p:spPr>
            <a:xfrm>
              <a:off x="7031861" y="1974618"/>
              <a:ext cx="338277" cy="1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/>
                <a:t>Cecum</a:t>
              </a:r>
              <a:endParaRPr lang="fr-FR" sz="1200" b="1" dirty="0"/>
            </a:p>
          </p:txBody>
        </p:sp>
        <p:sp>
          <p:nvSpPr>
            <p:cNvPr id="179" name="ZoneTexte 178"/>
            <p:cNvSpPr txBox="1"/>
            <p:nvPr/>
          </p:nvSpPr>
          <p:spPr>
            <a:xfrm>
              <a:off x="8091253" y="1972785"/>
              <a:ext cx="305016" cy="1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Colon</a:t>
              </a:r>
              <a:endParaRPr lang="fr-FR" sz="1200" b="1" dirty="0"/>
            </a:p>
          </p:txBody>
        </p:sp>
        <p:sp>
          <p:nvSpPr>
            <p:cNvPr id="180" name="Rectangle 179"/>
            <p:cNvSpPr/>
            <p:nvPr/>
          </p:nvSpPr>
          <p:spPr>
            <a:xfrm>
              <a:off x="5977189" y="1838128"/>
              <a:ext cx="2613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>
                  <a:solidFill>
                    <a:srgbClr val="FF0000"/>
                  </a:solidFill>
                </a:rPr>
                <a:t>+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81" name="Rectangle 180"/>
            <p:cNvSpPr/>
            <p:nvPr/>
          </p:nvSpPr>
          <p:spPr>
            <a:xfrm>
              <a:off x="8589600" y="1845597"/>
              <a:ext cx="2626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008000"/>
                  </a:solidFill>
                </a:rPr>
                <a:t>0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182" name="Rectangle 181"/>
            <p:cNvSpPr/>
            <p:nvPr/>
          </p:nvSpPr>
          <p:spPr>
            <a:xfrm>
              <a:off x="8070759" y="1854691"/>
              <a:ext cx="2626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FF0000"/>
                  </a:solidFill>
                </a:rPr>
                <a:t>0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83" name="Rectangle 182"/>
            <p:cNvSpPr/>
            <p:nvPr/>
          </p:nvSpPr>
          <p:spPr>
            <a:xfrm>
              <a:off x="7518065" y="1832890"/>
              <a:ext cx="2626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008000"/>
                  </a:solidFill>
                </a:rPr>
                <a:t>0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184" name="Rectangle 183"/>
            <p:cNvSpPr/>
            <p:nvPr/>
          </p:nvSpPr>
          <p:spPr>
            <a:xfrm>
              <a:off x="7024624" y="1841984"/>
              <a:ext cx="2626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 smtClean="0">
                  <a:solidFill>
                    <a:srgbClr val="FF0000"/>
                  </a:solidFill>
                </a:rPr>
                <a:t>0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185" name="Rectangle 184"/>
            <p:cNvSpPr/>
            <p:nvPr/>
          </p:nvSpPr>
          <p:spPr>
            <a:xfrm>
              <a:off x="6492017" y="1856767"/>
              <a:ext cx="2613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baseline="30000" dirty="0">
                  <a:solidFill>
                    <a:srgbClr val="008000"/>
                  </a:solidFill>
                </a:rPr>
                <a:t>+</a:t>
              </a:r>
              <a:endParaRPr lang="fr-FR" dirty="0">
                <a:solidFill>
                  <a:srgbClr val="008000"/>
                </a:solidFill>
              </a:endParaRPr>
            </a:p>
          </p:txBody>
        </p:sp>
      </p:grpSp>
      <p:cxnSp>
        <p:nvCxnSpPr>
          <p:cNvPr id="187" name="Connecteur droit 186"/>
          <p:cNvCxnSpPr/>
          <p:nvPr/>
        </p:nvCxnSpPr>
        <p:spPr>
          <a:xfrm flipH="1">
            <a:off x="5574090" y="6009683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8" name="Connecteur droit 187"/>
          <p:cNvCxnSpPr/>
          <p:nvPr/>
        </p:nvCxnSpPr>
        <p:spPr>
          <a:xfrm flipH="1">
            <a:off x="663360" y="5969895"/>
            <a:ext cx="3054315" cy="0"/>
          </a:xfrm>
          <a:prstGeom prst="line">
            <a:avLst/>
          </a:prstGeom>
          <a:ln w="19050" cmpd="sng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9" name="ZoneTexte 188"/>
          <p:cNvSpPr txBox="1"/>
          <p:nvPr/>
        </p:nvSpPr>
        <p:spPr>
          <a:xfrm>
            <a:off x="4125232" y="5410900"/>
            <a:ext cx="941459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6 </a:t>
            </a:r>
            <a:r>
              <a:rPr lang="fr-FR" sz="1200" b="1" dirty="0" err="1" smtClean="0">
                <a:latin typeface="Arial"/>
                <a:cs typeface="Arial"/>
              </a:rPr>
              <a:t>hours</a:t>
            </a:r>
            <a:r>
              <a:rPr lang="fr-FR" sz="1200" b="1" smtClean="0">
                <a:latin typeface="Arial"/>
                <a:cs typeface="Arial"/>
              </a:rPr>
              <a:t> PI </a:t>
            </a:r>
            <a:endParaRPr lang="fr-FR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405934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84</Words>
  <Application>Microsoft Macintosh PowerPoint</Application>
  <PresentationFormat>Présentation à l'écran (4:3)</PresentationFormat>
  <Paragraphs>13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 U 106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rota Czerucka</dc:creator>
  <cp:lastModifiedBy>Dorota Czerucka</cp:lastModifiedBy>
  <cp:revision>15</cp:revision>
  <dcterms:created xsi:type="dcterms:W3CDTF">2013-09-04T14:07:46Z</dcterms:created>
  <dcterms:modified xsi:type="dcterms:W3CDTF">2014-07-01T14:55:28Z</dcterms:modified>
</cp:coreProperties>
</file>